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356"/>
    <p:restoredTop sz="86391"/>
  </p:normalViewPr>
  <p:slideViewPr>
    <p:cSldViewPr>
      <p:cViewPr varScale="1">
        <p:scale>
          <a:sx n="116" d="100"/>
          <a:sy n="116" d="100"/>
        </p:scale>
        <p:origin x="184" y="13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6/6/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6/6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6/6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6/6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6/6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6/6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6/6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6/6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6/6/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6/6/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6/6/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6/6/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6/6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6/6/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6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493521" y="3879706"/>
            <a:ext cx="1432560" cy="225312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2000" b="1" dirty="0"/>
              <a:t>The Assessment of Left Ventricular Mechanical Dyssynchrony from gated </a:t>
            </a:r>
            <a:r>
              <a:rPr lang="en-US" sz="2000" b="1" baseline="30000" dirty="0"/>
              <a:t>99m</a:t>
            </a:r>
            <a:r>
              <a:rPr lang="en-US" sz="2000" b="1" dirty="0"/>
              <a:t>Tc-tetrofosmin SPECT and gated </a:t>
            </a:r>
            <a:r>
              <a:rPr lang="en-US" sz="2000" b="1" baseline="30000" dirty="0"/>
              <a:t>18</a:t>
            </a:r>
            <a:r>
              <a:rPr lang="en-US" sz="2000" b="1" dirty="0"/>
              <a:t>F-FDG PET by QGS – A Comparative Study </a:t>
            </a:r>
            <a:endParaRPr lang="de-DE" sz="20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de-DE" sz="1200" dirty="0"/>
              <a:t>Sebastian Lehner; Frank Philipp </a:t>
            </a:r>
            <a:r>
              <a:rPr lang="de-DE" sz="1200" dirty="0" err="1"/>
              <a:t>Graner</a:t>
            </a:r>
            <a:r>
              <a:rPr lang="de-DE" sz="1200" dirty="0"/>
              <a:t>, Maximilian Fischer, Harun Ilhan, Peter Bartenstein, Andrei </a:t>
            </a:r>
            <a:r>
              <a:rPr lang="de-DE" sz="1200" dirty="0" err="1"/>
              <a:t>Todica</a:t>
            </a:r>
            <a:endParaRPr lang="de-DE" sz="1200" dirty="0"/>
          </a:p>
          <a:p>
            <a:endParaRPr lang="de-DE" sz="1200" dirty="0"/>
          </a:p>
          <a:p>
            <a:pPr marL="0" lvl="1"/>
            <a:r>
              <a:rPr lang="en-US" altLang="en-US" sz="1000" dirty="0"/>
              <a:t>Departments of Nuclear Medicine and Cardiology, University Hospital Munich, Munich, Germany and Ambulatory Healthcare Center Dr. </a:t>
            </a:r>
            <a:r>
              <a:rPr lang="en-US" altLang="en-US" sz="1000" dirty="0" err="1"/>
              <a:t>Neumaier</a:t>
            </a:r>
            <a:r>
              <a:rPr lang="en-US" altLang="en-US" sz="1000" dirty="0"/>
              <a:t> &amp; Colleagues, Radiology, Nuclear Medicine, Radiation Therapy, Regensburg, Germany</a:t>
            </a:r>
          </a:p>
          <a:p>
            <a:endParaRPr lang="en-US" altLang="en-US" sz="4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Grafik 14" descr="Ein Bild, das Person, Wand, Mann, drinnen enthält.&#10;&#10;Automatisch generierte Beschreibung">
            <a:extLst>
              <a:ext uri="{FF2B5EF4-FFF2-40B4-BE49-F238E27FC236}">
                <a16:creationId xmlns:a16="http://schemas.microsoft.com/office/drawing/2014/main" id="{EFC23C03-95CE-004D-9E5D-178181BD756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3945890"/>
            <a:ext cx="1362775" cy="213614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Gated SPECT is the standard method for phase analysis in Nuclear Cardiology.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Phase analysis has been implemented in gated FDG-PET as well.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Conflicting studies on the performance of gated PET vs. gated SPECT with regard to phase analysis.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So far no cut-off values have been defined for FDG-PET to detect LVMD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 retrospective</a:t>
            </a:r>
            <a:endParaRPr lang="en-US" altLang="en-US" sz="2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patients that presented for viability imaging to our institution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(s): comparison of gated FDG-PET and gated SPECT for phase analysis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point(s): best parameter and cut-off value for PET to detect LVMD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 BW, Phase SD, Entropy</a:t>
            </a:r>
            <a:endParaRPr lang="en-US" altLang="en-US" sz="2800" baseline="-25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417FA9D6-6AB7-1641-9F57-EE78F1E981DF}"/>
              </a:ext>
            </a:extLst>
          </p:cNvPr>
          <p:cNvSpPr txBox="1"/>
          <p:nvPr/>
        </p:nvSpPr>
        <p:spPr>
          <a:xfrm>
            <a:off x="508890" y="4818062"/>
            <a:ext cx="319370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bove </a:t>
            </a:r>
            <a:r>
              <a:rPr lang="en-US" sz="1200" dirty="0"/>
              <a:t>Entropy at cut-off of 62% best to discriminate dyssynchrony.</a:t>
            </a:r>
            <a:endParaRPr lang="de-DE" sz="1200" b="1" dirty="0"/>
          </a:p>
          <a:p>
            <a:r>
              <a:rPr lang="en-US" sz="1200" b="1" dirty="0"/>
              <a:t>Left </a:t>
            </a:r>
            <a:r>
              <a:rPr lang="en-US" sz="1200" dirty="0"/>
              <a:t>Good correlation between gated PET and SPECT, but methods should not be used interchangeably.</a:t>
            </a:r>
          </a:p>
        </p:txBody>
      </p:sp>
      <p:pic>
        <p:nvPicPr>
          <p:cNvPr id="13" name="Grafik 12">
            <a:extLst>
              <a:ext uri="{FF2B5EF4-FFF2-40B4-BE49-F238E27FC236}">
                <a16:creationId xmlns:a16="http://schemas.microsoft.com/office/drawing/2014/main" id="{D9F84846-7608-0047-BC5B-7CD5D39BD3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10000" y="1600200"/>
            <a:ext cx="4866701" cy="424614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90CBF974-C308-2C48-89BB-2EAF55FF612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0933" y="1600200"/>
            <a:ext cx="3141662" cy="314166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Gated SPECT and gated PET can assess LVMD.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The methods cannot be used interchangeably.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2800" dirty="0"/>
              <a:t>Establishing reference ranges and cut-off values is difficult due to the lack of an external gold standard.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With gated SPECT as a standard of reference</a:t>
            </a:r>
            <a:r>
              <a:rPr lang="en-US" altLang="en-US" sz="2800"/>
              <a:t>, FDG-PET </a:t>
            </a:r>
            <a:r>
              <a:rPr lang="en-US" altLang="en-US" sz="2800" dirty="0"/>
              <a:t>Entropy at a cut-off value of 62% is the best parameter </a:t>
            </a:r>
            <a:r>
              <a:rPr lang="en-US" altLang="en-US" sz="2800"/>
              <a:t>to discriminate LVMD.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387</Words>
  <Application>Microsoft Macintosh PowerPoint</Application>
  <PresentationFormat>Bildschirmpräsentation (4:3)</PresentationFormat>
  <Paragraphs>36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5</vt:i4>
      </vt:variant>
    </vt:vector>
  </HeadingPairs>
  <TitlesOfParts>
    <vt:vector size="13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The Assessment of Left Ventricular Mechanical Dyssynchrony from gated 99mTc-tetrofosmin SPECT and gated 18F-FDG PET by QGS – A Comparative Study 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Ein Microsoft Office-Anwender</cp:lastModifiedBy>
  <cp:revision>132</cp:revision>
  <dcterms:created xsi:type="dcterms:W3CDTF">2011-04-18T21:44:13Z</dcterms:created>
  <dcterms:modified xsi:type="dcterms:W3CDTF">2021-06-06T11:59:50Z</dcterms:modified>
</cp:coreProperties>
</file>